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669088" cy="987266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9668" autoAdjust="0"/>
  </p:normalViewPr>
  <p:slideViewPr>
    <p:cSldViewPr>
      <p:cViewPr>
        <p:scale>
          <a:sx n="50" d="100"/>
          <a:sy n="50" d="100"/>
        </p:scale>
        <p:origin x="1704" y="101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62446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38797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00523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009594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6394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13776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4725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29108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548979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496407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633998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FA74B-58E6-42F7-B4E3-D248C7049621}" type="datetimeFigureOut">
              <a:rPr lang="fr-BE" smtClean="0"/>
              <a:t>13/02/2019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45F606-8FE8-4670-A8BB-1A90A7B23747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05670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0" y="179512"/>
            <a:ext cx="552037" cy="481224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spcBef>
                <a:spcPct val="0"/>
              </a:spcBef>
              <a:buNone/>
              <a:defRPr sz="2200" b="1" kern="1200">
                <a:solidFill>
                  <a:schemeClr val="bg2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fr-BE" sz="2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/>
          <p:cNvGrpSpPr>
            <a:grpSpLocks noChangeAspect="1"/>
          </p:cNvGrpSpPr>
          <p:nvPr/>
        </p:nvGrpSpPr>
        <p:grpSpPr>
          <a:xfrm>
            <a:off x="404664" y="1835696"/>
            <a:ext cx="5766586" cy="3790732"/>
            <a:chOff x="3088730" y="546123"/>
            <a:chExt cx="4012678" cy="2637781"/>
          </a:xfrm>
        </p:grpSpPr>
        <p:grpSp>
          <p:nvGrpSpPr>
            <p:cNvPr id="31" name="Group 30"/>
            <p:cNvGrpSpPr/>
            <p:nvPr/>
          </p:nvGrpSpPr>
          <p:grpSpPr>
            <a:xfrm>
              <a:off x="3088730" y="546123"/>
              <a:ext cx="4012678" cy="2421260"/>
              <a:chOff x="4585628" y="-2152603"/>
              <a:chExt cx="5423243" cy="2729588"/>
            </a:xfrm>
          </p:grpSpPr>
          <p:pic>
            <p:nvPicPr>
              <p:cNvPr id="33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3671"/>
              <a:stretch/>
            </p:blipFill>
            <p:spPr bwMode="auto">
              <a:xfrm>
                <a:off x="4927808" y="-2152603"/>
                <a:ext cx="5081063" cy="242734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4" name="Straight Arrow Connector 33"/>
              <p:cNvCxnSpPr/>
              <p:nvPr/>
            </p:nvCxnSpPr>
            <p:spPr>
              <a:xfrm>
                <a:off x="5169521" y="574291"/>
                <a:ext cx="4817925" cy="0"/>
              </a:xfrm>
              <a:prstGeom prst="straightConnector1">
                <a:avLst/>
              </a:prstGeom>
              <a:ln w="15875">
                <a:solidFill>
                  <a:schemeClr val="tx1">
                    <a:lumMod val="50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Arrow Connector 34"/>
              <p:cNvCxnSpPr/>
              <p:nvPr/>
            </p:nvCxnSpPr>
            <p:spPr>
              <a:xfrm flipV="1">
                <a:off x="5169521" y="168403"/>
                <a:ext cx="0" cy="405843"/>
              </a:xfrm>
              <a:prstGeom prst="straightConnector1">
                <a:avLst/>
              </a:prstGeom>
              <a:ln w="15875">
                <a:solidFill>
                  <a:schemeClr val="tx1">
                    <a:lumMod val="50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/>
              <p:cNvCxnSpPr/>
              <p:nvPr/>
            </p:nvCxnSpPr>
            <p:spPr>
              <a:xfrm flipV="1">
                <a:off x="6419921" y="171142"/>
                <a:ext cx="0" cy="405843"/>
              </a:xfrm>
              <a:prstGeom prst="straightConnector1">
                <a:avLst/>
              </a:prstGeom>
              <a:ln w="15875">
                <a:solidFill>
                  <a:schemeClr val="tx1">
                    <a:lumMod val="50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/>
              <p:cNvCxnSpPr/>
              <p:nvPr/>
            </p:nvCxnSpPr>
            <p:spPr>
              <a:xfrm flipV="1">
                <a:off x="7673172" y="168401"/>
                <a:ext cx="0" cy="405843"/>
              </a:xfrm>
              <a:prstGeom prst="straightConnector1">
                <a:avLst/>
              </a:prstGeom>
              <a:ln w="15875">
                <a:solidFill>
                  <a:schemeClr val="tx1">
                    <a:lumMod val="50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/>
              <p:nvPr/>
            </p:nvCxnSpPr>
            <p:spPr>
              <a:xfrm flipV="1">
                <a:off x="8881792" y="168401"/>
                <a:ext cx="0" cy="405843"/>
              </a:xfrm>
              <a:prstGeom prst="straightConnector1">
                <a:avLst/>
              </a:prstGeom>
              <a:ln w="15875">
                <a:solidFill>
                  <a:schemeClr val="tx1">
                    <a:lumMod val="50000"/>
                  </a:schemeClr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 rot="16200000">
                <a:off x="4793969" y="128106"/>
                <a:ext cx="583894" cy="30847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4</a:t>
                </a:r>
                <a:endParaRPr lang="en-US" sz="140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5949719" y="8552"/>
                <a:ext cx="800550" cy="30847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LADR</a:t>
                </a:r>
                <a:endParaRPr lang="en-US" sz="100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7206113" y="8552"/>
                <a:ext cx="800550" cy="30847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41</a:t>
                </a:r>
                <a:endParaRPr lang="en-US" sz="120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6200000">
                <a:off x="8397064" y="8552"/>
                <a:ext cx="800550" cy="308473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1a</a:t>
                </a:r>
                <a:endParaRPr lang="en-US" sz="105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4585628" y="-1093167"/>
                <a:ext cx="583893" cy="30847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dium</a:t>
                </a:r>
                <a:endParaRPr lang="en-US" sz="100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607510" y="-2070596"/>
                <a:ext cx="583894" cy="308472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noAutofit/>
              </a:bodyPr>
              <a:lstStyle/>
              <a:p>
                <a:r>
                  <a:rPr lang="en-US" sz="900" dirty="0">
                    <a:solidFill>
                      <a:schemeClr val="tx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WC</a:t>
                </a:r>
                <a:endParaRPr lang="en-US" sz="1000" dirty="0">
                  <a:solidFill>
                    <a:schemeClr val="tx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3493706" y="2953072"/>
              <a:ext cx="5040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L-10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9CC2006F-F035-4E19-B009-78558C85AA8D}"/>
              </a:ext>
            </a:extLst>
          </p:cNvPr>
          <p:cNvSpPr txBox="1"/>
          <p:nvPr/>
        </p:nvSpPr>
        <p:spPr>
          <a:xfrm>
            <a:off x="260648" y="6300192"/>
            <a:ext cx="633670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Phenotyping of IL-10-producing cells responding to inactivated 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phylococcus aureus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gen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plot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sent the expression of the markers CD14, HLA-DR, CD1a and CD141 by IL-10-producing cells. Data were generated using flow cytometry upon overnight in vitro stimulation of peripheral blood mononuclear cells with killed whole-cell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phylococcus aureu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gen (KWC). Numbers in the quadrant gates of the plots denominate each distinct population based on its marker expression. Representative plots of 1 of the 14 healthy donors tested are shown.</a:t>
            </a:r>
          </a:p>
        </p:txBody>
      </p:sp>
    </p:spTree>
    <p:extLst>
      <p:ext uri="{BB962C8B-B14F-4D97-AF65-F5344CB8AC3E}">
        <p14:creationId xmlns:p14="http://schemas.microsoft.com/office/powerpoint/2010/main" val="2422550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GlaxoSmithKline Biological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en Oe</dc:creator>
  <cp:lastModifiedBy>Ellen Oe</cp:lastModifiedBy>
  <cp:revision>135</cp:revision>
  <cp:lastPrinted>2016-06-10T16:48:21Z</cp:lastPrinted>
  <dcterms:created xsi:type="dcterms:W3CDTF">2016-05-25T09:23:14Z</dcterms:created>
  <dcterms:modified xsi:type="dcterms:W3CDTF">2019-02-13T13:25:10Z</dcterms:modified>
</cp:coreProperties>
</file>